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  <p:sldId id="257" r:id="rId3"/>
    <p:sldId id="259" r:id="rId4"/>
    <p:sldId id="25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534"/>
    <p:restoredTop sz="96327"/>
  </p:normalViewPr>
  <p:slideViewPr>
    <p:cSldViewPr snapToGrid="0">
      <p:cViewPr varScale="1">
        <p:scale>
          <a:sx n="120" d="100"/>
          <a:sy n="120" d="100"/>
        </p:scale>
        <p:origin x="44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5C7AF2-F3EF-D7E2-BE1F-9BAF0078392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E9D54E4-C6EC-FBD4-7B7D-268ECF8C61C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CE8AE0-5469-526A-EC12-ED287A5141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CE246-22AE-8841-B01C-A3FEFE4C777A}" type="datetimeFigureOut">
              <a:rPr lang="en-US" smtClean="0"/>
              <a:t>4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02C99B-269C-0195-08C4-09BBC732A5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6A6F8C-006C-94B7-F7B9-2E4CE399F2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EA5D4-5471-7846-8E09-83C5AFCBCC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69172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6D5BDC-7C4D-9145-E85D-B08342102E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5722254-F83B-D748-B05F-D7336DFCC1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D488A5-D703-7A36-6CDE-316323DCEC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CE246-22AE-8841-B01C-A3FEFE4C777A}" type="datetimeFigureOut">
              <a:rPr lang="en-US" smtClean="0"/>
              <a:t>4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E307D2-69C6-F409-B397-08CE2E27AA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07C0D4-5C1C-70F5-795E-64C89347C5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EA5D4-5471-7846-8E09-83C5AFCBCC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11678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B52EDD3-4D0F-5060-59CD-435600072B5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C256A03-7E0B-650C-DD14-2EBD4B77345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F2C56B-37D1-9BBC-445F-AAD59AB490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CE246-22AE-8841-B01C-A3FEFE4C777A}" type="datetimeFigureOut">
              <a:rPr lang="en-US" smtClean="0"/>
              <a:t>4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EAECC2-AF3F-FF40-02DD-5525AEB9D7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844312-FF80-157D-78DF-67C946C749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EA5D4-5471-7846-8E09-83C5AFCBCC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2008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6B36F6-72D3-F4DC-74B2-E22892735B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DFD6D1-03B6-E705-F2A7-A2ECCA3D11B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0D5E54-37E2-CEB7-9F26-B6FA9E8A53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CE246-22AE-8841-B01C-A3FEFE4C777A}" type="datetimeFigureOut">
              <a:rPr lang="en-US" smtClean="0"/>
              <a:t>4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DE63CD-01A8-0C27-84C2-A0179CD3B2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C3656E-9CB4-F5A3-03B1-3120D93178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EA5D4-5471-7846-8E09-83C5AFCBCC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0602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A4FDF4-E538-3F01-37B7-E433ACEB7B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BDACA3-115E-81ED-997E-6BB63E6F9F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7D2A42-525A-7A9A-6731-B61B0E12E5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CE246-22AE-8841-B01C-A3FEFE4C777A}" type="datetimeFigureOut">
              <a:rPr lang="en-US" smtClean="0"/>
              <a:t>4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871ADC-1884-6BF4-D6FC-9824E3E7A7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33FCEA-7A75-184F-9EF9-9A09D32348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EA5D4-5471-7846-8E09-83C5AFCBCC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8416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C2EF2E-6FAC-E62A-2B93-FCBF9213FC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5AD9EE-81F4-0403-B836-470428335EA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3AA5734-E170-E36F-059E-8D6DDA727F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E68A20-A413-16B3-40EF-AF93170D0C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CE246-22AE-8841-B01C-A3FEFE4C777A}" type="datetimeFigureOut">
              <a:rPr lang="en-US" smtClean="0"/>
              <a:t>4/2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A85EC2C-60AD-DB7B-7E29-D28A8E15B3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D60340-6ECA-D183-E92F-83391E62B0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EA5D4-5471-7846-8E09-83C5AFCBCC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06163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5EEA68-A79D-4908-6792-1E2EC21577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1D4E45-CC78-A9AF-FAA2-8C9D6B8E65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446779A-1EC5-356E-1B78-DCD2BB0D7F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6D9DD98-552A-0C83-8D02-44F0001F009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1BCCB48-A277-C85B-CB5D-C51FA458860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4AD8D82-6955-CF8E-E485-CE833DBADD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CE246-22AE-8841-B01C-A3FEFE4C777A}" type="datetimeFigureOut">
              <a:rPr lang="en-US" smtClean="0"/>
              <a:t>4/25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E570F5C-2E48-1C8F-0965-4E0623D9E2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A34658D-64FC-085A-E994-B5A88D9F15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EA5D4-5471-7846-8E09-83C5AFCBCC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04086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E8A57A-73D7-B647-08B3-128EDDA7E9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F99B8EB-7AB7-6087-9139-618E38B696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CE246-22AE-8841-B01C-A3FEFE4C777A}" type="datetimeFigureOut">
              <a:rPr lang="en-US" smtClean="0"/>
              <a:t>4/25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1ED12BD-77FB-7936-C2FF-8C7AE394E2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AB1B15F-0301-922E-849F-B419CAEA3D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EA5D4-5471-7846-8E09-83C5AFCBCC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66300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D348430-4824-BB89-9254-79617FF807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CE246-22AE-8841-B01C-A3FEFE4C777A}" type="datetimeFigureOut">
              <a:rPr lang="en-US" smtClean="0"/>
              <a:t>4/25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3D5CB2C-D6A3-CEA3-02D7-969A277AB9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19C085C-43F8-65B1-BC13-EE1CE2F255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EA5D4-5471-7846-8E09-83C5AFCBCC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01208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896E80-A9D3-412C-9DDB-7C57DB5A62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896C100-031E-87C2-1B11-0E34A774735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216EC81-2F9A-26A1-D036-3D5196C51B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B9954EA-45D1-48D2-E743-C17BFCD8E9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CE246-22AE-8841-B01C-A3FEFE4C777A}" type="datetimeFigureOut">
              <a:rPr lang="en-US" smtClean="0"/>
              <a:t>4/2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08BBA9-CAAE-3846-5FAF-0F2E20A671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DE2E1D-368B-4071-4C1D-227FE0F8B7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EA5D4-5471-7846-8E09-83C5AFCBCC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2759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0BACE7-B24F-D998-AE2F-F734FB1F80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E31699D-2551-7653-B80B-E3ECC93990C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5A505FA-80EB-9B3E-C0F8-3388B918D3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1DAC96-299B-2324-2F98-D0356E2A4F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CE246-22AE-8841-B01C-A3FEFE4C777A}" type="datetimeFigureOut">
              <a:rPr lang="en-US" smtClean="0"/>
              <a:t>4/2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B3B009-766C-1231-713B-CFDD10C43D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D70409-8814-EBAB-A4A2-97A94BF8E6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EA5D4-5471-7846-8E09-83C5AFCBCC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66716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A13A403-4B22-57BF-91BF-5F36ED08CC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A5CC28-012D-5EFC-DF0F-E0E1A65FC3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4F6E40-5C22-77F6-F19B-0D7B49F8C08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ACE246-22AE-8841-B01C-A3FEFE4C777A}" type="datetimeFigureOut">
              <a:rPr lang="en-US" smtClean="0"/>
              <a:t>4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22EA14-521E-10B0-B3E3-9F39D7CF665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D86B68-0973-9278-DB81-2B0149B2F5C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BEA5D4-5471-7846-8E09-83C5AFCBCC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26410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974137B-690C-C71F-5B15-977F53013971}"/>
              </a:ext>
            </a:extLst>
          </p:cNvPr>
          <p:cNvSpPr txBox="1"/>
          <p:nvPr/>
        </p:nvSpPr>
        <p:spPr>
          <a:xfrm>
            <a:off x="1022112" y="361507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AD7677B-F1E5-33A1-401E-32DBC1F1557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87800" y="1854200"/>
            <a:ext cx="4216400" cy="31496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80397A2-1A92-E86A-66BB-47F19432B26C}"/>
              </a:ext>
            </a:extLst>
          </p:cNvPr>
          <p:cNvSpPr txBox="1"/>
          <p:nvPr/>
        </p:nvSpPr>
        <p:spPr>
          <a:xfrm>
            <a:off x="4720856" y="1297172"/>
            <a:ext cx="31790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ull    miRNA       Null      miRNA</a:t>
            </a:r>
          </a:p>
        </p:txBody>
      </p:sp>
    </p:spTree>
    <p:extLst>
      <p:ext uri="{BB962C8B-B14F-4D97-AF65-F5344CB8AC3E}">
        <p14:creationId xmlns:p14="http://schemas.microsoft.com/office/powerpoint/2010/main" val="16215048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FF0E4CF-1B0C-A1D6-A151-5C11E1951FCE}"/>
              </a:ext>
            </a:extLst>
          </p:cNvPr>
          <p:cNvSpPr txBox="1"/>
          <p:nvPr/>
        </p:nvSpPr>
        <p:spPr>
          <a:xfrm>
            <a:off x="1022112" y="361507"/>
            <a:ext cx="688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DK1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BCABDD0-3437-99CC-4639-1967C005A62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78864" y="730839"/>
            <a:ext cx="3741479" cy="505497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17ECD64-A16E-3A89-77FD-A6C7381CC3E1}"/>
              </a:ext>
            </a:extLst>
          </p:cNvPr>
          <p:cNvSpPr txBox="1"/>
          <p:nvPr/>
        </p:nvSpPr>
        <p:spPr>
          <a:xfrm>
            <a:off x="4241268" y="1329070"/>
            <a:ext cx="33762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ull    miRNA       Null     miRNA M</a:t>
            </a:r>
          </a:p>
        </p:txBody>
      </p:sp>
    </p:spTree>
    <p:extLst>
      <p:ext uri="{BB962C8B-B14F-4D97-AF65-F5344CB8AC3E}">
        <p14:creationId xmlns:p14="http://schemas.microsoft.com/office/powerpoint/2010/main" val="29325083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B29B4A7-46AB-37F5-C89B-D311AD645DB7}"/>
              </a:ext>
            </a:extLst>
          </p:cNvPr>
          <p:cNvSpPr txBox="1"/>
          <p:nvPr/>
        </p:nvSpPr>
        <p:spPr>
          <a:xfrm>
            <a:off x="1808922" y="457200"/>
            <a:ext cx="780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PEB3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EBE97F4-086E-DFB2-D7D3-728EE818F3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7459256" y="1041021"/>
            <a:ext cx="1839430" cy="477595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FB88E0B-0E91-538A-0560-3ECCC1E8A84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48624" y="457200"/>
            <a:ext cx="1584122" cy="6025586"/>
          </a:xfrm>
          <a:prstGeom prst="rect">
            <a:avLst/>
          </a:prstGeom>
        </p:spPr>
      </p:pic>
      <p:sp>
        <p:nvSpPr>
          <p:cNvPr id="9" name="Rounded Rectangle 8">
            <a:extLst>
              <a:ext uri="{FF2B5EF4-FFF2-40B4-BE49-F238E27FC236}">
                <a16:creationId xmlns:a16="http://schemas.microsoft.com/office/drawing/2014/main" id="{1B0B11BC-F5B6-7B29-4D64-3E44618482B4}"/>
              </a:ext>
            </a:extLst>
          </p:cNvPr>
          <p:cNvSpPr/>
          <p:nvPr/>
        </p:nvSpPr>
        <p:spPr>
          <a:xfrm>
            <a:off x="3466213" y="4146698"/>
            <a:ext cx="1266532" cy="563525"/>
          </a:xfrm>
          <a:prstGeom prst="round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Rounded Rectangle 9">
            <a:extLst>
              <a:ext uri="{FF2B5EF4-FFF2-40B4-BE49-F238E27FC236}">
                <a16:creationId xmlns:a16="http://schemas.microsoft.com/office/drawing/2014/main" id="{F8548260-360F-38A6-8A88-150CE006E23C}"/>
              </a:ext>
            </a:extLst>
          </p:cNvPr>
          <p:cNvSpPr/>
          <p:nvPr/>
        </p:nvSpPr>
        <p:spPr>
          <a:xfrm>
            <a:off x="8032154" y="4309730"/>
            <a:ext cx="1266532" cy="563525"/>
          </a:xfrm>
          <a:prstGeom prst="round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BF3996D-4A28-DA6F-F0E6-109472374CC9}"/>
              </a:ext>
            </a:extLst>
          </p:cNvPr>
          <p:cNvSpPr txBox="1"/>
          <p:nvPr/>
        </p:nvSpPr>
        <p:spPr>
          <a:xfrm>
            <a:off x="3435572" y="2004803"/>
            <a:ext cx="17876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ull    miRNA     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3E8768A-84F6-5837-5754-E6EDB945D789}"/>
              </a:ext>
            </a:extLst>
          </p:cNvPr>
          <p:cNvSpPr txBox="1"/>
          <p:nvPr/>
        </p:nvSpPr>
        <p:spPr>
          <a:xfrm>
            <a:off x="7961510" y="2189469"/>
            <a:ext cx="17876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ull    miRNA      </a:t>
            </a:r>
          </a:p>
        </p:txBody>
      </p:sp>
    </p:spTree>
    <p:extLst>
      <p:ext uri="{BB962C8B-B14F-4D97-AF65-F5344CB8AC3E}">
        <p14:creationId xmlns:p14="http://schemas.microsoft.com/office/powerpoint/2010/main" val="21236333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9513C95-4A2A-A53E-7747-EB3E0EB51FD6}"/>
              </a:ext>
            </a:extLst>
          </p:cNvPr>
          <p:cNvSpPr txBox="1"/>
          <p:nvPr/>
        </p:nvSpPr>
        <p:spPr>
          <a:xfrm>
            <a:off x="1488559" y="446568"/>
            <a:ext cx="15736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clin B1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1E55CB7-2B84-3759-6841-80BCEE04B9E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35400" y="1066800"/>
            <a:ext cx="4521200" cy="47244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6746B39B-CE72-D42F-0E45-8652AE8654C6}"/>
              </a:ext>
            </a:extLst>
          </p:cNvPr>
          <p:cNvSpPr txBox="1"/>
          <p:nvPr/>
        </p:nvSpPr>
        <p:spPr>
          <a:xfrm>
            <a:off x="4114800" y="1275907"/>
            <a:ext cx="3456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iRNA        Null         Null      MiRNA</a:t>
            </a:r>
          </a:p>
        </p:txBody>
      </p:sp>
    </p:spTree>
    <p:extLst>
      <p:ext uri="{BB962C8B-B14F-4D97-AF65-F5344CB8AC3E}">
        <p14:creationId xmlns:p14="http://schemas.microsoft.com/office/powerpoint/2010/main" val="6969101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24</TotalTime>
  <Words>22</Words>
  <Application>Microsoft Macintosh PowerPoint</Application>
  <PresentationFormat>Widescreen</PresentationFormat>
  <Paragraphs>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ng Wei</dc:creator>
  <cp:lastModifiedBy>Ning Wei</cp:lastModifiedBy>
  <cp:revision>2</cp:revision>
  <dcterms:created xsi:type="dcterms:W3CDTF">2025-04-25T14:59:24Z</dcterms:created>
  <dcterms:modified xsi:type="dcterms:W3CDTF">2025-04-29T02:43:35Z</dcterms:modified>
</cp:coreProperties>
</file>